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58" y="35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164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482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6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600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400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287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44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898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79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803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94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4FB98C-9E8C-4D2C-8B60-52E9517FE8A7}" type="datetimeFigureOut">
              <a:rPr lang="en-US" smtClean="0"/>
              <a:t>7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36904-DB5C-4E00-A15A-2B4EC3F8C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125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Content Placeholder 1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3544" t="14501"/>
          <a:stretch/>
        </p:blipFill>
        <p:spPr>
          <a:xfrm>
            <a:off x="1623518" y="682387"/>
            <a:ext cx="8944964" cy="372036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063087" y="4653086"/>
            <a:ext cx="806582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upplemental Figure</a:t>
            </a:r>
            <a:endParaRPr lang="ja-JP" altLang="ja-JP" dirty="0"/>
          </a:p>
          <a:p>
            <a:r>
              <a:rPr lang="en-US" altLang="ja-JP" dirty="0"/>
              <a:t>Representative image of event-related potential (ERP) during ASSR.</a:t>
            </a:r>
            <a:endParaRPr lang="ja-JP" altLang="ja-JP" dirty="0"/>
          </a:p>
          <a:p>
            <a:r>
              <a:rPr lang="en-US" altLang="ja-JP" dirty="0"/>
              <a:t>For illustration, a representative ERP image (trial by time) from a subject at baseline recording is shown. An averaged ERP wave form is in the panel at bottom. The onset of click trains is set as time zero. A number of epochs is 182 after outlier rejection (see Experimental procedure).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3621171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71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da, Sokichi</dc:creator>
  <cp:lastModifiedBy>Yamazaki, Mayako(山﨑 真也子)</cp:lastModifiedBy>
  <cp:revision>9</cp:revision>
  <dcterms:created xsi:type="dcterms:W3CDTF">2020-05-14T18:18:50Z</dcterms:created>
  <dcterms:modified xsi:type="dcterms:W3CDTF">2020-07-01T01:47:04Z</dcterms:modified>
</cp:coreProperties>
</file>